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53928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3" d="100"/>
          <a:sy n="53" d="100"/>
        </p:scale>
        <p:origin x="1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5447" y="1472842"/>
            <a:ext cx="8108395" cy="3133172"/>
          </a:xfrm>
        </p:spPr>
        <p:txBody>
          <a:bodyPr anchor="b"/>
          <a:lstStyle>
            <a:lvl1pPr algn="ctr">
              <a:defRPr sz="625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92411" y="4726842"/>
            <a:ext cx="7154466" cy="2172804"/>
          </a:xfrm>
        </p:spPr>
        <p:txBody>
          <a:bodyPr/>
          <a:lstStyle>
            <a:lvl1pPr marL="0" indent="0" algn="ctr">
              <a:buNone/>
              <a:defRPr sz="2504"/>
            </a:lvl1pPr>
            <a:lvl2pPr marL="476951" indent="0" algn="ctr">
              <a:buNone/>
              <a:defRPr sz="2086"/>
            </a:lvl2pPr>
            <a:lvl3pPr marL="953902" indent="0" algn="ctr">
              <a:buNone/>
              <a:defRPr sz="1878"/>
            </a:lvl3pPr>
            <a:lvl4pPr marL="1430853" indent="0" algn="ctr">
              <a:buNone/>
              <a:defRPr sz="1669"/>
            </a:lvl4pPr>
            <a:lvl5pPr marL="1907804" indent="0" algn="ctr">
              <a:buNone/>
              <a:defRPr sz="1669"/>
            </a:lvl5pPr>
            <a:lvl6pPr marL="2384755" indent="0" algn="ctr">
              <a:buNone/>
              <a:defRPr sz="1669"/>
            </a:lvl6pPr>
            <a:lvl7pPr marL="2861706" indent="0" algn="ctr">
              <a:buNone/>
              <a:defRPr sz="1669"/>
            </a:lvl7pPr>
            <a:lvl8pPr marL="3338657" indent="0" algn="ctr">
              <a:buNone/>
              <a:defRPr sz="1669"/>
            </a:lvl8pPr>
            <a:lvl9pPr marL="3815608" indent="0" algn="ctr">
              <a:buNone/>
              <a:defRPr sz="1669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9118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112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26553" y="479142"/>
            <a:ext cx="2056909" cy="762669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5826" y="479142"/>
            <a:ext cx="6051486" cy="762669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014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1480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0858" y="2243638"/>
            <a:ext cx="8227636" cy="3743557"/>
          </a:xfrm>
        </p:spPr>
        <p:txBody>
          <a:bodyPr anchor="b"/>
          <a:lstStyle>
            <a:lvl1pPr>
              <a:defRPr sz="625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0858" y="6022610"/>
            <a:ext cx="8227636" cy="1968648"/>
          </a:xfrm>
        </p:spPr>
        <p:txBody>
          <a:bodyPr/>
          <a:lstStyle>
            <a:lvl1pPr marL="0" indent="0">
              <a:buNone/>
              <a:defRPr sz="2504">
                <a:solidFill>
                  <a:schemeClr val="tx1"/>
                </a:solidFill>
              </a:defRPr>
            </a:lvl1pPr>
            <a:lvl2pPr marL="476951" indent="0">
              <a:buNone/>
              <a:defRPr sz="2086">
                <a:solidFill>
                  <a:schemeClr val="tx1">
                    <a:tint val="75000"/>
                  </a:schemeClr>
                </a:solidFill>
              </a:defRPr>
            </a:lvl2pPr>
            <a:lvl3pPr marL="953902" indent="0">
              <a:buNone/>
              <a:defRPr sz="1878">
                <a:solidFill>
                  <a:schemeClr val="tx1">
                    <a:tint val="75000"/>
                  </a:schemeClr>
                </a:solidFill>
              </a:defRPr>
            </a:lvl3pPr>
            <a:lvl4pPr marL="1430853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4pPr>
            <a:lvl5pPr marL="1907804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5pPr>
            <a:lvl6pPr marL="2384755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6pPr>
            <a:lvl7pPr marL="2861706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7pPr>
            <a:lvl8pPr marL="3338657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8pPr>
            <a:lvl9pPr marL="3815608" indent="0">
              <a:buNone/>
              <a:defRPr sz="16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6106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55826" y="2395710"/>
            <a:ext cx="4054197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29265" y="2395710"/>
            <a:ext cx="4054197" cy="571012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2202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479144"/>
            <a:ext cx="8227636" cy="173949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7070" y="2206137"/>
            <a:ext cx="4035565" cy="1081194"/>
          </a:xfrm>
        </p:spPr>
        <p:txBody>
          <a:bodyPr anchor="b"/>
          <a:lstStyle>
            <a:lvl1pPr marL="0" indent="0">
              <a:buNone/>
              <a:defRPr sz="2504" b="1"/>
            </a:lvl1pPr>
            <a:lvl2pPr marL="476951" indent="0">
              <a:buNone/>
              <a:defRPr sz="2086" b="1"/>
            </a:lvl2pPr>
            <a:lvl3pPr marL="953902" indent="0">
              <a:buNone/>
              <a:defRPr sz="1878" b="1"/>
            </a:lvl3pPr>
            <a:lvl4pPr marL="1430853" indent="0">
              <a:buNone/>
              <a:defRPr sz="1669" b="1"/>
            </a:lvl4pPr>
            <a:lvl5pPr marL="1907804" indent="0">
              <a:buNone/>
              <a:defRPr sz="1669" b="1"/>
            </a:lvl5pPr>
            <a:lvl6pPr marL="2384755" indent="0">
              <a:buNone/>
              <a:defRPr sz="1669" b="1"/>
            </a:lvl6pPr>
            <a:lvl7pPr marL="2861706" indent="0">
              <a:buNone/>
              <a:defRPr sz="1669" b="1"/>
            </a:lvl7pPr>
            <a:lvl8pPr marL="3338657" indent="0">
              <a:buNone/>
              <a:defRPr sz="1669" b="1"/>
            </a:lvl8pPr>
            <a:lvl9pPr marL="3815608" indent="0">
              <a:buNone/>
              <a:defRPr sz="1669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7070" y="3287331"/>
            <a:ext cx="4035565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29265" y="2206137"/>
            <a:ext cx="4055440" cy="1081194"/>
          </a:xfrm>
        </p:spPr>
        <p:txBody>
          <a:bodyPr anchor="b"/>
          <a:lstStyle>
            <a:lvl1pPr marL="0" indent="0">
              <a:buNone/>
              <a:defRPr sz="2504" b="1"/>
            </a:lvl1pPr>
            <a:lvl2pPr marL="476951" indent="0">
              <a:buNone/>
              <a:defRPr sz="2086" b="1"/>
            </a:lvl2pPr>
            <a:lvl3pPr marL="953902" indent="0">
              <a:buNone/>
              <a:defRPr sz="1878" b="1"/>
            </a:lvl3pPr>
            <a:lvl4pPr marL="1430853" indent="0">
              <a:buNone/>
              <a:defRPr sz="1669" b="1"/>
            </a:lvl4pPr>
            <a:lvl5pPr marL="1907804" indent="0">
              <a:buNone/>
              <a:defRPr sz="1669" b="1"/>
            </a:lvl5pPr>
            <a:lvl6pPr marL="2384755" indent="0">
              <a:buNone/>
              <a:defRPr sz="1669" b="1"/>
            </a:lvl6pPr>
            <a:lvl7pPr marL="2861706" indent="0">
              <a:buNone/>
              <a:defRPr sz="1669" b="1"/>
            </a:lvl7pPr>
            <a:lvl8pPr marL="3338657" indent="0">
              <a:buNone/>
              <a:defRPr sz="1669" b="1"/>
            </a:lvl8pPr>
            <a:lvl9pPr marL="3815608" indent="0">
              <a:buNone/>
              <a:defRPr sz="1669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29265" y="3287331"/>
            <a:ext cx="4055440" cy="483516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021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878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0247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599969"/>
            <a:ext cx="3076669" cy="2099892"/>
          </a:xfrm>
        </p:spPr>
        <p:txBody>
          <a:bodyPr anchor="b"/>
          <a:lstStyle>
            <a:lvl1pPr>
              <a:defRPr sz="333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55440" y="1295769"/>
            <a:ext cx="4829265" cy="6395505"/>
          </a:xfrm>
        </p:spPr>
        <p:txBody>
          <a:bodyPr/>
          <a:lstStyle>
            <a:lvl1pPr>
              <a:defRPr sz="3338"/>
            </a:lvl1pPr>
            <a:lvl2pPr>
              <a:defRPr sz="2921"/>
            </a:lvl2pPr>
            <a:lvl3pPr>
              <a:defRPr sz="2504"/>
            </a:lvl3pPr>
            <a:lvl4pPr>
              <a:defRPr sz="2086"/>
            </a:lvl4pPr>
            <a:lvl5pPr>
              <a:defRPr sz="2086"/>
            </a:lvl5pPr>
            <a:lvl6pPr>
              <a:defRPr sz="2086"/>
            </a:lvl6pPr>
            <a:lvl7pPr>
              <a:defRPr sz="2086"/>
            </a:lvl7pPr>
            <a:lvl8pPr>
              <a:defRPr sz="2086"/>
            </a:lvl8pPr>
            <a:lvl9pPr>
              <a:defRPr sz="2086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57068" y="2699862"/>
            <a:ext cx="3076669" cy="5001827"/>
          </a:xfrm>
        </p:spPr>
        <p:txBody>
          <a:bodyPr/>
          <a:lstStyle>
            <a:lvl1pPr marL="0" indent="0">
              <a:buNone/>
              <a:defRPr sz="1669"/>
            </a:lvl1pPr>
            <a:lvl2pPr marL="476951" indent="0">
              <a:buNone/>
              <a:defRPr sz="1460"/>
            </a:lvl2pPr>
            <a:lvl3pPr marL="953902" indent="0">
              <a:buNone/>
              <a:defRPr sz="1252"/>
            </a:lvl3pPr>
            <a:lvl4pPr marL="1430853" indent="0">
              <a:buNone/>
              <a:defRPr sz="1043"/>
            </a:lvl4pPr>
            <a:lvl5pPr marL="1907804" indent="0">
              <a:buNone/>
              <a:defRPr sz="1043"/>
            </a:lvl5pPr>
            <a:lvl6pPr marL="2384755" indent="0">
              <a:buNone/>
              <a:defRPr sz="1043"/>
            </a:lvl6pPr>
            <a:lvl7pPr marL="2861706" indent="0">
              <a:buNone/>
              <a:defRPr sz="1043"/>
            </a:lvl7pPr>
            <a:lvl8pPr marL="3338657" indent="0">
              <a:buNone/>
              <a:defRPr sz="1043"/>
            </a:lvl8pPr>
            <a:lvl9pPr marL="3815608" indent="0">
              <a:buNone/>
              <a:defRPr sz="104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6885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068" y="599969"/>
            <a:ext cx="3076669" cy="2099892"/>
          </a:xfrm>
        </p:spPr>
        <p:txBody>
          <a:bodyPr anchor="b"/>
          <a:lstStyle>
            <a:lvl1pPr>
              <a:defRPr sz="333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55440" y="1295769"/>
            <a:ext cx="4829265" cy="6395505"/>
          </a:xfrm>
        </p:spPr>
        <p:txBody>
          <a:bodyPr anchor="t"/>
          <a:lstStyle>
            <a:lvl1pPr marL="0" indent="0">
              <a:buNone/>
              <a:defRPr sz="3338"/>
            </a:lvl1pPr>
            <a:lvl2pPr marL="476951" indent="0">
              <a:buNone/>
              <a:defRPr sz="2921"/>
            </a:lvl2pPr>
            <a:lvl3pPr marL="953902" indent="0">
              <a:buNone/>
              <a:defRPr sz="2504"/>
            </a:lvl3pPr>
            <a:lvl4pPr marL="1430853" indent="0">
              <a:buNone/>
              <a:defRPr sz="2086"/>
            </a:lvl4pPr>
            <a:lvl5pPr marL="1907804" indent="0">
              <a:buNone/>
              <a:defRPr sz="2086"/>
            </a:lvl5pPr>
            <a:lvl6pPr marL="2384755" indent="0">
              <a:buNone/>
              <a:defRPr sz="2086"/>
            </a:lvl6pPr>
            <a:lvl7pPr marL="2861706" indent="0">
              <a:buNone/>
              <a:defRPr sz="2086"/>
            </a:lvl7pPr>
            <a:lvl8pPr marL="3338657" indent="0">
              <a:buNone/>
              <a:defRPr sz="2086"/>
            </a:lvl8pPr>
            <a:lvl9pPr marL="3815608" indent="0">
              <a:buNone/>
              <a:defRPr sz="208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57068" y="2699862"/>
            <a:ext cx="3076669" cy="5001827"/>
          </a:xfrm>
        </p:spPr>
        <p:txBody>
          <a:bodyPr/>
          <a:lstStyle>
            <a:lvl1pPr marL="0" indent="0">
              <a:buNone/>
              <a:defRPr sz="1669"/>
            </a:lvl1pPr>
            <a:lvl2pPr marL="476951" indent="0">
              <a:buNone/>
              <a:defRPr sz="1460"/>
            </a:lvl2pPr>
            <a:lvl3pPr marL="953902" indent="0">
              <a:buNone/>
              <a:defRPr sz="1252"/>
            </a:lvl3pPr>
            <a:lvl4pPr marL="1430853" indent="0">
              <a:buNone/>
              <a:defRPr sz="1043"/>
            </a:lvl4pPr>
            <a:lvl5pPr marL="1907804" indent="0">
              <a:buNone/>
              <a:defRPr sz="1043"/>
            </a:lvl5pPr>
            <a:lvl6pPr marL="2384755" indent="0">
              <a:buNone/>
              <a:defRPr sz="1043"/>
            </a:lvl6pPr>
            <a:lvl7pPr marL="2861706" indent="0">
              <a:buNone/>
              <a:defRPr sz="1043"/>
            </a:lvl7pPr>
            <a:lvl8pPr marL="3338657" indent="0">
              <a:buNone/>
              <a:defRPr sz="1043"/>
            </a:lvl8pPr>
            <a:lvl9pPr marL="3815608" indent="0">
              <a:buNone/>
              <a:defRPr sz="104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580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55826" y="479144"/>
            <a:ext cx="822763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826" y="2395710"/>
            <a:ext cx="822763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826" y="8341240"/>
            <a:ext cx="214634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D88D2-4983-4719-B78C-B2FEE006B56F}" type="datetimeFigureOut">
              <a:rPr lang="ko-KR" altLang="en-US" smtClean="0"/>
              <a:t>2019-1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59889" y="8341240"/>
            <a:ext cx="321951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37122" y="8341240"/>
            <a:ext cx="214634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911B2-6E82-4B96-A7DB-DA9B4A9C4D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792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53902" rtl="0" eaLnBrk="1" latinLnBrk="1" hangingPunct="1">
        <a:lnSpc>
          <a:spcPct val="90000"/>
        </a:lnSpc>
        <a:spcBef>
          <a:spcPct val="0"/>
        </a:spcBef>
        <a:buNone/>
        <a:defRPr sz="45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8476" indent="-238476" algn="l" defTabSz="953902" rtl="0" eaLnBrk="1" latinLnBrk="1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2921" kern="1200">
          <a:solidFill>
            <a:schemeClr val="tx1"/>
          </a:solidFill>
          <a:latin typeface="+mn-lt"/>
          <a:ea typeface="+mn-ea"/>
          <a:cs typeface="+mn-cs"/>
        </a:defRPr>
      </a:lvl1pPr>
      <a:lvl2pPr marL="715427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2504" kern="1200">
          <a:solidFill>
            <a:schemeClr val="tx1"/>
          </a:solidFill>
          <a:latin typeface="+mn-lt"/>
          <a:ea typeface="+mn-ea"/>
          <a:cs typeface="+mn-cs"/>
        </a:defRPr>
      </a:lvl2pPr>
      <a:lvl3pPr marL="1192378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2086" kern="1200">
          <a:solidFill>
            <a:schemeClr val="tx1"/>
          </a:solidFill>
          <a:latin typeface="+mn-lt"/>
          <a:ea typeface="+mn-ea"/>
          <a:cs typeface="+mn-cs"/>
        </a:defRPr>
      </a:lvl3pPr>
      <a:lvl4pPr marL="1669329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4pPr>
      <a:lvl5pPr marL="2146280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5pPr>
      <a:lvl6pPr marL="2623231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6pPr>
      <a:lvl7pPr marL="3100182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7pPr>
      <a:lvl8pPr marL="3577133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8pPr>
      <a:lvl9pPr marL="4054084" indent="-238476" algn="l" defTabSz="953902" rtl="0" eaLnBrk="1" latinLnBrk="1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8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1pPr>
      <a:lvl2pPr marL="476951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2pPr>
      <a:lvl3pPr marL="953902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3pPr>
      <a:lvl4pPr marL="1430853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4pPr>
      <a:lvl5pPr marL="1907804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5pPr>
      <a:lvl6pPr marL="2384755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6pPr>
      <a:lvl7pPr marL="2861706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7pPr>
      <a:lvl8pPr marL="3338657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8pPr>
      <a:lvl9pPr marL="3815608" algn="l" defTabSz="953902" rtl="0" eaLnBrk="1" latinLnBrk="1" hangingPunct="1">
        <a:defRPr sz="18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AED73389-97A8-48FA-902F-EAA8228BE30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55"/>
          <a:stretch/>
        </p:blipFill>
        <p:spPr>
          <a:xfrm>
            <a:off x="3136683" y="3462969"/>
            <a:ext cx="1036800" cy="103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그림 11" descr="실내, 벽이(가) 표시된 사진&#10;&#10;자동 생성된 설명">
            <a:extLst>
              <a:ext uri="{FF2B5EF4-FFF2-40B4-BE49-F238E27FC236}">
                <a16:creationId xmlns:a16="http://schemas.microsoft.com/office/drawing/2014/main" id="{580151C3-2A21-4CE1-BAAD-7A7C608BDC9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20" t="10190" r="9420" b="10190"/>
          <a:stretch/>
        </p:blipFill>
        <p:spPr>
          <a:xfrm>
            <a:off x="4251244" y="3462969"/>
            <a:ext cx="1036800" cy="103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그림 12" descr="하얀색, 벽이(가) 표시된 사진&#10;&#10;자동 생성된 설명">
            <a:extLst>
              <a:ext uri="{FF2B5EF4-FFF2-40B4-BE49-F238E27FC236}">
                <a16:creationId xmlns:a16="http://schemas.microsoft.com/office/drawing/2014/main" id="{B97AEACB-97EF-48BE-AE63-5BAEEE5154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190" t="11644" r="10190" b="11644"/>
          <a:stretch/>
        </p:blipFill>
        <p:spPr>
          <a:xfrm>
            <a:off x="5364213" y="3462969"/>
            <a:ext cx="1036800" cy="1036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DBA83D7-EA0D-4F25-942F-D2E0C22B12A1}"/>
              </a:ext>
            </a:extLst>
          </p:cNvPr>
          <p:cNvSpPr txBox="1"/>
          <p:nvPr/>
        </p:nvSpPr>
        <p:spPr>
          <a:xfrm>
            <a:off x="2511843" y="4530050"/>
            <a:ext cx="7489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g3 (</a:t>
            </a:r>
            <a:r>
              <a:rPr lang="en-US" altLang="ko-KR" sz="1050" dirty="0" err="1">
                <a:latin typeface="Arial" pitchFamily="34" charset="0"/>
                <a:ea typeface="Arial Unicode MS" pitchFamily="50" charset="-127"/>
                <a:cs typeface="Arial" pitchFamily="34" charset="0"/>
              </a:rPr>
              <a:t>μM</a:t>
            </a:r>
            <a:r>
              <a:rPr lang="en-US" altLang="ko-KR" sz="1050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44F64E4-AE0D-40B5-9BE9-A2B936DDB581}"/>
              </a:ext>
            </a:extLst>
          </p:cNvPr>
          <p:cNvSpPr txBox="1"/>
          <p:nvPr/>
        </p:nvSpPr>
        <p:spPr>
          <a:xfrm>
            <a:off x="3106379" y="4530050"/>
            <a:ext cx="329463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-                           20                            40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D7402D-B541-44CA-8E7A-E4945C40438C}"/>
              </a:ext>
            </a:extLst>
          </p:cNvPr>
          <p:cNvSpPr txBox="1"/>
          <p:nvPr/>
        </p:nvSpPr>
        <p:spPr>
          <a:xfrm>
            <a:off x="35495" y="44624"/>
            <a:ext cx="92491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Figure S1. 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Reduced lipid droplet size of dose-dependently Rg3 treated mature 3T3-L1 stained by Oil-Red-O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FA3D454-F8D3-4042-9FF6-ED09BECBD4D2}"/>
              </a:ext>
            </a:extLst>
          </p:cNvPr>
          <p:cNvSpPr txBox="1"/>
          <p:nvPr/>
        </p:nvSpPr>
        <p:spPr>
          <a:xfrm>
            <a:off x="290107" y="5836900"/>
            <a:ext cx="9249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Figure S1. 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Reduced lipid droplet size of dose-dependently Rg3 treated mature 3T3-L1 stained by Oil-Red-O. (A) Oil-Red-O staining showing the accumulation of lipid droplets in differentiated 3T3-L1 cells treated with Rg3 (20, 40 </a:t>
            </a:r>
            <a:r>
              <a:rPr lang="en-US" altLang="ko-KR" dirty="0" err="1">
                <a:latin typeface="Arial" pitchFamily="34" charset="0"/>
                <a:cs typeface="Arial" pitchFamily="34" charset="0"/>
                <a:sym typeface="Wingdings" pitchFamily="2" charset="2"/>
              </a:rPr>
              <a:t>μM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) for 24 h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66FD61-A388-44D3-BA60-9E0D384D3629}"/>
              </a:ext>
            </a:extLst>
          </p:cNvPr>
          <p:cNvSpPr txBox="1"/>
          <p:nvPr/>
        </p:nvSpPr>
        <p:spPr>
          <a:xfrm>
            <a:off x="2511843" y="3079261"/>
            <a:ext cx="3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A</a:t>
            </a:r>
            <a:endParaRPr lang="en-US" altLang="ko-KR" sz="1800" b="1" dirty="0">
              <a:latin typeface="Arial" pitchFamily="34" charset="0"/>
              <a:cs typeface="Arial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1527363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D5AB2489-9B47-4F22-A976-C45F6375A3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388" t="8390" r="29971" b="62042"/>
          <a:stretch/>
        </p:blipFill>
        <p:spPr>
          <a:xfrm>
            <a:off x="3149539" y="3461377"/>
            <a:ext cx="1029467" cy="10383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8AD6662-F669-4865-B934-8F895067B02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364" t="48170" r="22063" b="28027"/>
          <a:stretch/>
        </p:blipFill>
        <p:spPr>
          <a:xfrm>
            <a:off x="4255175" y="3461377"/>
            <a:ext cx="1038392" cy="10383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8EEB7E42-02B5-4F8E-B02F-D769FDB213C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48" t="23835" r="74845" b="47846"/>
          <a:stretch/>
        </p:blipFill>
        <p:spPr>
          <a:xfrm>
            <a:off x="5369736" y="3461377"/>
            <a:ext cx="1038393" cy="10383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E33CC7-14F9-4568-82C4-6C406A4A6236}"/>
              </a:ext>
            </a:extLst>
          </p:cNvPr>
          <p:cNvSpPr txBox="1"/>
          <p:nvPr/>
        </p:nvSpPr>
        <p:spPr>
          <a:xfrm>
            <a:off x="2518959" y="4529153"/>
            <a:ext cx="7489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g3 (</a:t>
            </a:r>
            <a:r>
              <a:rPr lang="en-US" altLang="ko-KR" sz="1050" dirty="0" err="1">
                <a:latin typeface="Arial" pitchFamily="34" charset="0"/>
                <a:ea typeface="Arial Unicode MS" pitchFamily="50" charset="-127"/>
                <a:cs typeface="Arial" pitchFamily="34" charset="0"/>
              </a:rPr>
              <a:t>μM</a:t>
            </a:r>
            <a:r>
              <a:rPr lang="en-US" altLang="ko-KR" sz="1050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6112C27-A2C7-431F-A2AE-606969900011}"/>
              </a:ext>
            </a:extLst>
          </p:cNvPr>
          <p:cNvSpPr txBox="1"/>
          <p:nvPr/>
        </p:nvSpPr>
        <p:spPr>
          <a:xfrm>
            <a:off x="3113495" y="4529153"/>
            <a:ext cx="329463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-                           40                            40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308C5B-5200-4C5A-BE3F-D9C2ED62AF92}"/>
              </a:ext>
            </a:extLst>
          </p:cNvPr>
          <p:cNvSpPr txBox="1"/>
          <p:nvPr/>
        </p:nvSpPr>
        <p:spPr>
          <a:xfrm>
            <a:off x="2571860" y="4761131"/>
            <a:ext cx="6960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CC (</a:t>
            </a:r>
            <a:r>
              <a:rPr lang="en-US" altLang="ko-KR" sz="1050" dirty="0" err="1">
                <a:latin typeface="Arial" pitchFamily="34" charset="0"/>
                <a:ea typeface="Arial Unicode MS" pitchFamily="50" charset="-127"/>
                <a:cs typeface="Arial" pitchFamily="34" charset="0"/>
              </a:rPr>
              <a:t>μM</a:t>
            </a:r>
            <a:r>
              <a:rPr lang="en-US" altLang="ko-KR" sz="1050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D14E0B8-1D89-4701-A3AC-62AB50A11C2B}"/>
              </a:ext>
            </a:extLst>
          </p:cNvPr>
          <p:cNvSpPr txBox="1"/>
          <p:nvPr/>
        </p:nvSpPr>
        <p:spPr>
          <a:xfrm>
            <a:off x="3113494" y="4761131"/>
            <a:ext cx="329463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-                            -                              10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B4F8C4-F18D-4A05-9FB1-EB8FDBFBC8F6}"/>
              </a:ext>
            </a:extLst>
          </p:cNvPr>
          <p:cNvSpPr txBox="1"/>
          <p:nvPr/>
        </p:nvSpPr>
        <p:spPr>
          <a:xfrm>
            <a:off x="61856" y="155994"/>
            <a:ext cx="92491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Figure S2. 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Reduced lipid droplet size of Rg3 was attenuated by co-treated with Compound C on mature 3T3-L1 stained by Oil-Red-O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473D8F-266E-446B-9FC0-A3CDDFB923E0}"/>
              </a:ext>
            </a:extLst>
          </p:cNvPr>
          <p:cNvSpPr txBox="1"/>
          <p:nvPr/>
        </p:nvSpPr>
        <p:spPr>
          <a:xfrm>
            <a:off x="290107" y="6512490"/>
            <a:ext cx="92491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Figure S2. 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Reduced lipid droplet size of Rg3 was attenuated by co-treated with Compound C on mature 3T3-L1 stained by Oil-Red-O. (A) Oil-Red-O staining showing the accumulation of lipid droplets in differentiated 3T3-L1 cells treated with Rg3 (40 </a:t>
            </a:r>
            <a:r>
              <a:rPr lang="en-US" altLang="ko-KR" dirty="0" err="1">
                <a:latin typeface="Arial" pitchFamily="34" charset="0"/>
                <a:cs typeface="Arial" pitchFamily="34" charset="0"/>
                <a:sym typeface="Wingdings" pitchFamily="2" charset="2"/>
              </a:rPr>
              <a:t>μM</a:t>
            </a:r>
            <a:r>
              <a:rPr lang="en-US" altLang="ko-KR" dirty="0">
                <a:latin typeface="Arial" pitchFamily="34" charset="0"/>
                <a:cs typeface="Arial" pitchFamily="34" charset="0"/>
                <a:sym typeface="Wingdings" pitchFamily="2" charset="2"/>
              </a:rPr>
              <a:t>) in combination with Compound C (CC, 10uM) for 24 h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A85A38E-C117-45D9-925F-282297F8E825}"/>
              </a:ext>
            </a:extLst>
          </p:cNvPr>
          <p:cNvSpPr txBox="1"/>
          <p:nvPr/>
        </p:nvSpPr>
        <p:spPr>
          <a:xfrm>
            <a:off x="2511843" y="3079261"/>
            <a:ext cx="3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  <a:sym typeface="Wingdings" pitchFamily="2" charset="2"/>
              </a:rPr>
              <a:t>A</a:t>
            </a:r>
            <a:endParaRPr lang="en-US" altLang="ko-KR" sz="1800" b="1" dirty="0">
              <a:latin typeface="Arial" pitchFamily="34" charset="0"/>
              <a:cs typeface="Arial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26874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70</Words>
  <Application>Microsoft Office PowerPoint</Application>
  <PresentationFormat>사용자 지정</PresentationFormat>
  <Paragraphs>1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AM</dc:creator>
  <cp:lastModifiedBy>NAM KIHONG</cp:lastModifiedBy>
  <cp:revision>3</cp:revision>
  <dcterms:created xsi:type="dcterms:W3CDTF">2019-05-19T12:02:58Z</dcterms:created>
  <dcterms:modified xsi:type="dcterms:W3CDTF">2019-12-28T13:50:54Z</dcterms:modified>
</cp:coreProperties>
</file>